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1476" y="4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esktop\stem%20cell%20international%20&#22823;&#20462;&#26448;&#26009;%2020150803\20150731&#20462;&#25913;\&#26032;&#24314;%20Microsoft%20Excel%20&#24037;&#20316;&#34920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1169901727400356"/>
          <c:y val="0.10437481773111694"/>
          <c:w val="0.68720991271439902"/>
          <c:h val="0.68103382910469523"/>
        </c:manualLayout>
      </c:layout>
      <c:barChart>
        <c:barDir val="col"/>
        <c:grouping val="clustered"/>
        <c:varyColors val="0"/>
        <c:ser>
          <c:idx val="0"/>
          <c:order val="0"/>
          <c:tx>
            <c:v>DMSO</c:v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H$21:$I$21</c:f>
                <c:numCache>
                  <c:formatCode>General</c:formatCode>
                  <c:ptCount val="2"/>
                  <c:pt idx="0">
                    <c:v>0.09</c:v>
                  </c:pt>
                  <c:pt idx="1">
                    <c:v>0.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F$11,Sheet1!$G$11)</c:f>
              <c:strCache>
                <c:ptCount val="2"/>
                <c:pt idx="0">
                  <c:v>AP1</c:v>
                </c:pt>
                <c:pt idx="1">
                  <c:v>AP2</c:v>
                </c:pt>
              </c:strCache>
            </c:strRef>
          </c:cat>
          <c:val>
            <c:numRef>
              <c:f>Sheet1!$F$8:$G$8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v>SC1</c:v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H$23:$I$23</c:f>
                <c:numCache>
                  <c:formatCode>General</c:formatCode>
                  <c:ptCount val="2"/>
                  <c:pt idx="0">
                    <c:v>0.06</c:v>
                  </c:pt>
                  <c:pt idx="1">
                    <c:v>0.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F$11,Sheet1!$G$11)</c:f>
              <c:strCache>
                <c:ptCount val="2"/>
                <c:pt idx="0">
                  <c:v>AP1</c:v>
                </c:pt>
                <c:pt idx="1">
                  <c:v>AP2</c:v>
                </c:pt>
              </c:strCache>
            </c:strRef>
          </c:cat>
          <c:val>
            <c:numRef>
              <c:f>Sheet1!$F$9:$G$9</c:f>
              <c:numCache>
                <c:formatCode>General</c:formatCode>
                <c:ptCount val="2"/>
                <c:pt idx="0">
                  <c:v>0.6</c:v>
                </c:pt>
                <c:pt idx="1">
                  <c:v>0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8613936"/>
        <c:axId val="158614496"/>
      </c:barChart>
      <c:catAx>
        <c:axId val="158613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8614496"/>
        <c:crosses val="autoZero"/>
        <c:auto val="1"/>
        <c:lblAlgn val="ctr"/>
        <c:lblOffset val="100"/>
        <c:noMultiLvlLbl val="0"/>
      </c:catAx>
      <c:valAx>
        <c:axId val="1586144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86139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7075535616187514"/>
          <c:y val="1.4467045785943424E-2"/>
          <c:w val="0.25969879627115577"/>
          <c:h val="0.2170144356955380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79BF6-46F5-4AB3-BEE1-ACD43B1A25B6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F0A5E-E36C-42BE-91DE-ECC3BEB3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42116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79BF6-46F5-4AB3-BEE1-ACD43B1A25B6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F0A5E-E36C-42BE-91DE-ECC3BEB3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974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79BF6-46F5-4AB3-BEE1-ACD43B1A25B6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F0A5E-E36C-42BE-91DE-ECC3BEB3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2610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79BF6-46F5-4AB3-BEE1-ACD43B1A25B6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F0A5E-E36C-42BE-91DE-ECC3BEB3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3526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79BF6-46F5-4AB3-BEE1-ACD43B1A25B6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F0A5E-E36C-42BE-91DE-ECC3BEB3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61828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79BF6-46F5-4AB3-BEE1-ACD43B1A25B6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F0A5E-E36C-42BE-91DE-ECC3BEB3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6804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79BF6-46F5-4AB3-BEE1-ACD43B1A25B6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F0A5E-E36C-42BE-91DE-ECC3BEB3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35982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79BF6-46F5-4AB3-BEE1-ACD43B1A25B6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F0A5E-E36C-42BE-91DE-ECC3BEB3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2364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79BF6-46F5-4AB3-BEE1-ACD43B1A25B6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F0A5E-E36C-42BE-91DE-ECC3BEB3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3157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79BF6-46F5-4AB3-BEE1-ACD43B1A25B6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F0A5E-E36C-42BE-91DE-ECC3BEB3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7286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79BF6-46F5-4AB3-BEE1-ACD43B1A25B6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F0A5E-E36C-42BE-91DE-ECC3BEB3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7698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779BF6-46F5-4AB3-BEE1-ACD43B1A25B6}" type="datetimeFigureOut">
              <a:rPr lang="zh-CN" altLang="en-US" smtClean="0"/>
              <a:t>2015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8F0A5E-E36C-42BE-91DE-ECC3BEB3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398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2021237"/>
              </p:ext>
            </p:extLst>
          </p:nvPr>
        </p:nvGraphicFramePr>
        <p:xfrm>
          <a:off x="3477597" y="2666266"/>
          <a:ext cx="4820242" cy="28817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Image" r:id="rId3" imgW="1468800" imgH="877680" progId="Photoshop.Image.13">
                  <p:embed/>
                </p:oleObj>
              </mc:Choice>
              <mc:Fallback>
                <p:oleObj name="Image" r:id="rId3" imgW="1468800" imgH="8776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77597" y="2666266"/>
                        <a:ext cx="4820242" cy="28817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8297839" y="3075296"/>
            <a:ext cx="14193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anog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8297839" y="4467367"/>
            <a:ext cx="14193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291619" y="2156694"/>
            <a:ext cx="14193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SC1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4162568" y="2138844"/>
            <a:ext cx="14193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545911" y="557716"/>
            <a:ext cx="19693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S2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11371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3172255"/>
              </p:ext>
            </p:extLst>
          </p:nvPr>
        </p:nvGraphicFramePr>
        <p:xfrm>
          <a:off x="4457700" y="1852612"/>
          <a:ext cx="3276600" cy="31527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6073140" y="2842260"/>
            <a:ext cx="647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*</a:t>
            </a:r>
            <a:endParaRPr lang="zh-CN" altLang="en-US" sz="1400" dirty="0"/>
          </a:p>
        </p:txBody>
      </p:sp>
      <p:sp>
        <p:nvSpPr>
          <p:cNvPr id="4" name="文本框 3"/>
          <p:cNvSpPr txBox="1"/>
          <p:nvPr/>
        </p:nvSpPr>
        <p:spPr>
          <a:xfrm>
            <a:off x="7178040" y="2606040"/>
            <a:ext cx="647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*</a:t>
            </a:r>
            <a:endParaRPr lang="zh-CN" altLang="en-US" sz="1400" dirty="0"/>
          </a:p>
        </p:txBody>
      </p:sp>
      <p:sp>
        <p:nvSpPr>
          <p:cNvPr id="5" name="文本框 4"/>
          <p:cNvSpPr txBox="1"/>
          <p:nvPr/>
        </p:nvSpPr>
        <p:spPr>
          <a:xfrm rot="16200000">
            <a:off x="3642778" y="3027044"/>
            <a:ext cx="23537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luciferase activity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491889" y="1542394"/>
            <a:ext cx="19693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S2B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0006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3</Words>
  <Application>Microsoft Office PowerPoint</Application>
  <PresentationFormat>宽屏</PresentationFormat>
  <Paragraphs>9</Paragraphs>
  <Slides>2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Office 主题</vt:lpstr>
      <vt:lpstr>Adobe Photoshop Image</vt:lpstr>
      <vt:lpstr>PowerPoint 演示文稿</vt:lpstr>
      <vt:lpstr>PowerPoint 演示文稿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微软用户</dc:creator>
  <cp:lastModifiedBy>微软用户</cp:lastModifiedBy>
  <cp:revision>3</cp:revision>
  <dcterms:created xsi:type="dcterms:W3CDTF">2015-08-13T03:25:17Z</dcterms:created>
  <dcterms:modified xsi:type="dcterms:W3CDTF">2015-08-13T18:57:09Z</dcterms:modified>
</cp:coreProperties>
</file>